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441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4530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5839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390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1540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371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393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232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8630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0470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675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08317-6B34-4649-9642-B2D01C165577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2302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0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8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74" t="32777" r="27821" b="62975"/>
          <a:stretch/>
        </p:blipFill>
        <p:spPr>
          <a:xfrm>
            <a:off x="3435006" y="2236212"/>
            <a:ext cx="2160000" cy="1602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5" name="Gerade Verbindung mit Pfeil 74"/>
          <p:cNvCxnSpPr/>
          <p:nvPr/>
        </p:nvCxnSpPr>
        <p:spPr>
          <a:xfrm flipH="1">
            <a:off x="5619381" y="246513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feld 75"/>
          <p:cNvSpPr txBox="1"/>
          <p:nvPr/>
        </p:nvSpPr>
        <p:spPr>
          <a:xfrm>
            <a:off x="5691381" y="236226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3239951" y="23954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8" name="Tabelle 7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9752231"/>
              </p:ext>
            </p:extLst>
          </p:nvPr>
        </p:nvGraphicFramePr>
        <p:xfrm>
          <a:off x="3435006" y="1546210"/>
          <a:ext cx="2160000" cy="683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000">
                  <a:extLst>
                    <a:ext uri="{9D8B030D-6E8A-4147-A177-3AD203B41FA5}">
                      <a16:colId xmlns:a16="http://schemas.microsoft.com/office/drawing/2014/main" val="2669136215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3647131408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141552620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3260762399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726284612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599857253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1192897036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3599808452"/>
                    </a:ext>
                  </a:extLst>
                </a:gridCol>
              </a:tblGrid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275720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40941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2039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767824"/>
                  </a:ext>
                </a:extLst>
              </a:tr>
            </a:tbl>
          </a:graphicData>
        </a:graphic>
      </p:graphicFrame>
      <p:sp>
        <p:nvSpPr>
          <p:cNvPr id="79" name="Textfeld 78"/>
          <p:cNvSpPr txBox="1"/>
          <p:nvPr/>
        </p:nvSpPr>
        <p:spPr>
          <a:xfrm>
            <a:off x="5552639" y="1698446"/>
            <a:ext cx="6944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1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5552639" y="1880116"/>
            <a:ext cx="9380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1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552639" y="2046961"/>
            <a:ext cx="10005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3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Gerade Verbindung mit Pfeil 81"/>
          <p:cNvCxnSpPr/>
          <p:nvPr/>
        </p:nvCxnSpPr>
        <p:spPr>
          <a:xfrm flipH="1">
            <a:off x="5619381" y="231223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feld 82"/>
          <p:cNvSpPr txBox="1"/>
          <p:nvPr/>
        </p:nvSpPr>
        <p:spPr>
          <a:xfrm>
            <a:off x="5691381" y="2209882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3224197" y="22148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237144" y="27161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Gerade Verbindung mit Pfeil 85"/>
          <p:cNvCxnSpPr/>
          <p:nvPr/>
        </p:nvCxnSpPr>
        <p:spPr>
          <a:xfrm flipH="1">
            <a:off x="5619381" y="279583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feld 86"/>
          <p:cNvSpPr txBox="1"/>
          <p:nvPr/>
        </p:nvSpPr>
        <p:spPr>
          <a:xfrm>
            <a:off x="5691381" y="2703732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Gerade Verbindung mit Pfeil 87"/>
          <p:cNvCxnSpPr/>
          <p:nvPr/>
        </p:nvCxnSpPr>
        <p:spPr>
          <a:xfrm flipH="1">
            <a:off x="5619381" y="293481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feld 88"/>
          <p:cNvSpPr txBox="1"/>
          <p:nvPr/>
        </p:nvSpPr>
        <p:spPr>
          <a:xfrm>
            <a:off x="5691381" y="2836804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3222860" y="28516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Grafik 9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35" t="44228" r="21760" b="51339"/>
          <a:stretch/>
        </p:blipFill>
        <p:spPr>
          <a:xfrm>
            <a:off x="3435006" y="2405852"/>
            <a:ext cx="2160000" cy="167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Grafik 9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31670" r="24791" b="63528"/>
          <a:stretch/>
        </p:blipFill>
        <p:spPr>
          <a:xfrm>
            <a:off x="3435006" y="2580318"/>
            <a:ext cx="2160000" cy="18116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3" name="Gerade Verbindung mit Pfeil 92"/>
          <p:cNvCxnSpPr/>
          <p:nvPr/>
        </p:nvCxnSpPr>
        <p:spPr>
          <a:xfrm flipH="1">
            <a:off x="5619381" y="2648673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feld 93"/>
          <p:cNvSpPr txBox="1"/>
          <p:nvPr/>
        </p:nvSpPr>
        <p:spPr>
          <a:xfrm>
            <a:off x="5691381" y="255226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3239951" y="25674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Grafik 9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7" t="41458" r="26168" b="55402"/>
          <a:stretch/>
        </p:blipFill>
        <p:spPr>
          <a:xfrm>
            <a:off x="3435006" y="2769946"/>
            <a:ext cx="2160000" cy="1184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Grafik 9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7" t="42382" r="21897" b="54663"/>
          <a:stretch/>
        </p:blipFill>
        <p:spPr>
          <a:xfrm>
            <a:off x="3435006" y="2895652"/>
            <a:ext cx="2160000" cy="1114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Grafik 9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2" t="42751" r="20933" b="53740"/>
          <a:stretch/>
        </p:blipFill>
        <p:spPr>
          <a:xfrm>
            <a:off x="3435006" y="3019834"/>
            <a:ext cx="2160000" cy="1323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9" name="Textfeld 98"/>
          <p:cNvSpPr txBox="1"/>
          <p:nvPr/>
        </p:nvSpPr>
        <p:spPr>
          <a:xfrm>
            <a:off x="3230002" y="30071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Gerade Verbindung mit Pfeil 99"/>
          <p:cNvCxnSpPr/>
          <p:nvPr/>
        </p:nvCxnSpPr>
        <p:spPr>
          <a:xfrm flipH="1">
            <a:off x="5619381" y="307332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feld 100"/>
          <p:cNvSpPr txBox="1"/>
          <p:nvPr/>
        </p:nvSpPr>
        <p:spPr>
          <a:xfrm>
            <a:off x="5691381" y="2972030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3756973" y="1314333"/>
            <a:ext cx="15160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1 </a:t>
            </a:r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3, 8 h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5552639" y="153584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3032536" y="2050549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3121691" y="1219634"/>
            <a:ext cx="228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432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74" t="32777" r="27821" b="62975"/>
          <a:stretch/>
        </p:blipFill>
        <p:spPr>
          <a:xfrm>
            <a:off x="584230" y="215312"/>
            <a:ext cx="2160000" cy="1602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Gerade Verbindung mit Pfeil 4"/>
          <p:cNvCxnSpPr/>
          <p:nvPr/>
        </p:nvCxnSpPr>
        <p:spPr>
          <a:xfrm flipH="1">
            <a:off x="7671700" y="34931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7743700" y="246444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292270" y="2796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2768605" y="29133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2840605" y="188982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73421" y="1939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35" t="44228" r="21760" b="51339"/>
          <a:stretch/>
        </p:blipFill>
        <p:spPr>
          <a:xfrm>
            <a:off x="5487325" y="290035"/>
            <a:ext cx="2160000" cy="167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8" t="22066" r="14458" b="14770"/>
          <a:stretch/>
        </p:blipFill>
        <p:spPr>
          <a:xfrm>
            <a:off x="5198248" y="656981"/>
            <a:ext cx="3142770" cy="2627939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43" t="8214" r="14044" b="13662"/>
          <a:stretch/>
        </p:blipFill>
        <p:spPr>
          <a:xfrm>
            <a:off x="4733364" y="3429000"/>
            <a:ext cx="4072538" cy="3250347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2" t="12277" r="20932" b="21419"/>
          <a:stretch/>
        </p:blipFill>
        <p:spPr>
          <a:xfrm>
            <a:off x="584230" y="630981"/>
            <a:ext cx="3104349" cy="2758568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0" t="5443" r="20244" b="21789"/>
          <a:stretch/>
        </p:blipFill>
        <p:spPr>
          <a:xfrm>
            <a:off x="261257" y="3651838"/>
            <a:ext cx="3719072" cy="3027509"/>
          </a:xfrm>
          <a:prstGeom prst="rect">
            <a:avLst/>
          </a:prstGeom>
        </p:spPr>
      </p:pic>
      <p:sp>
        <p:nvSpPr>
          <p:cNvPr id="32" name="Rechteck 31"/>
          <p:cNvSpPr/>
          <p:nvPr/>
        </p:nvSpPr>
        <p:spPr>
          <a:xfrm>
            <a:off x="153815" y="372919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153815" y="45163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153815" y="46037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153815" y="46950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153815" y="47957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153815" y="49809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153815" y="51933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153815" y="55575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153815" y="57643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153815" y="60281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153815" y="62758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153815" y="43562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844300" y="428398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918520" y="1446197"/>
            <a:ext cx="2372850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Rechteck 45"/>
          <p:cNvSpPr/>
          <p:nvPr/>
        </p:nvSpPr>
        <p:spPr>
          <a:xfrm>
            <a:off x="4954213" y="372919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4954213" y="45163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4954213" y="46037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4954213" y="46950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4954213" y="47957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4954213" y="49809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4954213" y="51933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4954213" y="55575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4954213" y="57643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4954213" y="60281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4954213" y="62758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4954213" y="43562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5644698" y="428398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9" name="Rechteck 58"/>
          <p:cNvSpPr/>
          <p:nvPr/>
        </p:nvSpPr>
        <p:spPr>
          <a:xfrm>
            <a:off x="5529436" y="1555925"/>
            <a:ext cx="240817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6800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5493519" y="1470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mit Pfeil 2"/>
          <p:cNvCxnSpPr/>
          <p:nvPr/>
        </p:nvCxnSpPr>
        <p:spPr>
          <a:xfrm flipH="1">
            <a:off x="7875756" y="226673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7947756" y="134575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31670" r="24791" b="63528"/>
          <a:stretch/>
        </p:blipFill>
        <p:spPr>
          <a:xfrm>
            <a:off x="468969" y="213636"/>
            <a:ext cx="2160000" cy="18116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Gerade Verbindung mit Pfeil 8"/>
          <p:cNvCxnSpPr/>
          <p:nvPr/>
        </p:nvCxnSpPr>
        <p:spPr>
          <a:xfrm flipH="1">
            <a:off x="2653344" y="281991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2725344" y="18558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73914" y="2007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7" t="41458" r="26168" b="55402"/>
          <a:stretch/>
        </p:blipFill>
        <p:spPr>
          <a:xfrm>
            <a:off x="5691381" y="200789"/>
            <a:ext cx="2160000" cy="1184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1" t="10615" r="17351" b="25482"/>
          <a:stretch/>
        </p:blipFill>
        <p:spPr>
          <a:xfrm>
            <a:off x="700377" y="466657"/>
            <a:ext cx="2958353" cy="265867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9" r="18453" b="23451"/>
          <a:stretch/>
        </p:blipFill>
        <p:spPr>
          <a:xfrm>
            <a:off x="273914" y="3577110"/>
            <a:ext cx="3811281" cy="3184840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8" t="22805" r="19004" b="18834"/>
          <a:stretch/>
        </p:blipFill>
        <p:spPr>
          <a:xfrm>
            <a:off x="5366150" y="572554"/>
            <a:ext cx="2989090" cy="2428155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591" b="17910"/>
          <a:stretch/>
        </p:blipFill>
        <p:spPr>
          <a:xfrm>
            <a:off x="4500941" y="3346589"/>
            <a:ext cx="4540880" cy="3415361"/>
          </a:xfrm>
          <a:prstGeom prst="rect">
            <a:avLst/>
          </a:prstGeom>
        </p:spPr>
      </p:pic>
      <p:sp>
        <p:nvSpPr>
          <p:cNvPr id="22" name="Rechteck 21"/>
          <p:cNvSpPr/>
          <p:nvPr/>
        </p:nvSpPr>
        <p:spPr>
          <a:xfrm>
            <a:off x="361284" y="384606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361284" y="46331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361284" y="47205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361284" y="48119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361284" y="49126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361284" y="50977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361284" y="53101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361284" y="56744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361284" y="58812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361284" y="61450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361284" y="63927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361284" y="44731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051769" y="440085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5" name="Rechteck 34"/>
          <p:cNvSpPr/>
          <p:nvPr/>
        </p:nvSpPr>
        <p:spPr>
          <a:xfrm>
            <a:off x="700377" y="1302568"/>
            <a:ext cx="255765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6" name="Rechteck 35"/>
          <p:cNvSpPr/>
          <p:nvPr/>
        </p:nvSpPr>
        <p:spPr>
          <a:xfrm>
            <a:off x="5224134" y="383510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24134" y="46222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24134" y="47096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224134" y="48009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224134" y="49016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24134" y="50868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24134" y="52992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24134" y="56634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24134" y="58702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24134" y="61340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24134" y="63817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24134" y="44621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914619" y="438989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9" name="Rechteck 48"/>
          <p:cNvSpPr/>
          <p:nvPr/>
        </p:nvSpPr>
        <p:spPr>
          <a:xfrm>
            <a:off x="5535475" y="1321654"/>
            <a:ext cx="2412281" cy="1459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1980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Gerade Verbindung mit Pfeil 1"/>
          <p:cNvCxnSpPr/>
          <p:nvPr/>
        </p:nvCxnSpPr>
        <p:spPr>
          <a:xfrm flipH="1">
            <a:off x="2891549" y="253084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2963549" y="155076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495028" y="1699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7" t="42382" r="21897" b="54663"/>
          <a:stretch/>
        </p:blipFill>
        <p:spPr>
          <a:xfrm>
            <a:off x="707174" y="213924"/>
            <a:ext cx="2160000" cy="1114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2" t="42751" r="20933" b="53740"/>
          <a:stretch/>
        </p:blipFill>
        <p:spPr>
          <a:xfrm>
            <a:off x="5671059" y="193020"/>
            <a:ext cx="2160000" cy="1323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5466055" y="1803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7855434" y="246514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7927434" y="145216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47" t="25760" r="14872" b="17541"/>
          <a:stretch/>
        </p:blipFill>
        <p:spPr>
          <a:xfrm>
            <a:off x="594929" y="652411"/>
            <a:ext cx="3150454" cy="2358998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769" b="18279"/>
          <a:stretch/>
        </p:blipFill>
        <p:spPr>
          <a:xfrm>
            <a:off x="115645" y="3338905"/>
            <a:ext cx="4809821" cy="3399993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87" t="18372" r="14045" b="20865"/>
          <a:stretch/>
        </p:blipFill>
        <p:spPr>
          <a:xfrm>
            <a:off x="5187358" y="567886"/>
            <a:ext cx="3127402" cy="2528047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87" r="13769" b="21788"/>
          <a:stretch/>
        </p:blipFill>
        <p:spPr>
          <a:xfrm>
            <a:off x="4986938" y="3484902"/>
            <a:ext cx="3895805" cy="3253996"/>
          </a:xfrm>
          <a:prstGeom prst="rect">
            <a:avLst/>
          </a:prstGeom>
        </p:spPr>
      </p:pic>
      <p:sp>
        <p:nvSpPr>
          <p:cNvPr id="14" name="Rechteck 13"/>
          <p:cNvSpPr/>
          <p:nvPr/>
        </p:nvSpPr>
        <p:spPr>
          <a:xfrm>
            <a:off x="1029155" y="386911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029155" y="4656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029155" y="47436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029155" y="48350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029155" y="49356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1029155" y="51208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1029155" y="53332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1029155" y="5697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1029155" y="59043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1029155" y="61680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1029155" y="64158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1029155" y="44961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1719640" y="44239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7" name="Rechteck 26"/>
          <p:cNvSpPr/>
          <p:nvPr/>
        </p:nvSpPr>
        <p:spPr>
          <a:xfrm>
            <a:off x="912738" y="1300308"/>
            <a:ext cx="24989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/>
          <p:cNvSpPr/>
          <p:nvPr/>
        </p:nvSpPr>
        <p:spPr>
          <a:xfrm>
            <a:off x="5063912" y="386911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063912" y="4656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063912" y="47436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063912" y="48350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063912" y="49356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063912" y="51208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063912" y="53332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063912" y="5697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063912" y="59043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063912" y="61680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063912" y="64158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063912" y="44961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754397" y="44239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1" name="Rechteck 40"/>
          <p:cNvSpPr/>
          <p:nvPr/>
        </p:nvSpPr>
        <p:spPr>
          <a:xfrm>
            <a:off x="5482115" y="1563956"/>
            <a:ext cx="2445319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6909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6</Words>
  <Application>Microsoft Office PowerPoint</Application>
  <PresentationFormat>Bildschirmpräsentation (4:3)</PresentationFormat>
  <Paragraphs>141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10-21T12:55:11Z</dcterms:created>
  <dcterms:modified xsi:type="dcterms:W3CDTF">2024-10-21T13:17:59Z</dcterms:modified>
</cp:coreProperties>
</file>